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sldIdLst>
    <p:sldId id="256" r:id="rId2"/>
  </p:sldIdLst>
  <p:sldSz cx="10799763" cy="71993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85911B6-EF1E-4B8F-86D9-D8F87711C7E7}" v="1" dt="2026-02-24T17:24:36.85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928"/>
  </p:normalViewPr>
  <p:slideViewPr>
    <p:cSldViewPr snapToGrid="0" snapToObjects="1">
      <p:cViewPr varScale="1">
        <p:scale>
          <a:sx n="68" d="100"/>
          <a:sy n="68" d="100"/>
        </p:scale>
        <p:origin x="123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ul Lopez Vazquez" userId="e5a892a4-e1e1-49e8-b5d8-d044f9c2b3a9" providerId="ADAL" clId="{BD1E8AB3-BF32-4259-9B28-E10CC2C2CBB6}"/>
    <pc:docChg chg="undo custSel modSld">
      <pc:chgData name="Saul Lopez Vazquez" userId="e5a892a4-e1e1-49e8-b5d8-d044f9c2b3a9" providerId="ADAL" clId="{BD1E8AB3-BF32-4259-9B28-E10CC2C2CBB6}" dt="2026-02-24T17:24:47.338" v="3" actId="1076"/>
      <pc:docMkLst>
        <pc:docMk/>
      </pc:docMkLst>
      <pc:sldChg chg="addSp modSp mod">
        <pc:chgData name="Saul Lopez Vazquez" userId="e5a892a4-e1e1-49e8-b5d8-d044f9c2b3a9" providerId="ADAL" clId="{BD1E8AB3-BF32-4259-9B28-E10CC2C2CBB6}" dt="2026-02-24T17:24:47.338" v="3" actId="1076"/>
        <pc:sldMkLst>
          <pc:docMk/>
          <pc:sldMk cId="2527868278" sldId="256"/>
        </pc:sldMkLst>
        <pc:spChg chg="add mod">
          <ac:chgData name="Saul Lopez Vazquez" userId="e5a892a4-e1e1-49e8-b5d8-d044f9c2b3a9" providerId="ADAL" clId="{BD1E8AB3-BF32-4259-9B28-E10CC2C2CBB6}" dt="2026-02-24T17:24:47.338" v="3" actId="1076"/>
          <ac:spMkLst>
            <pc:docMk/>
            <pc:sldMk cId="2527868278" sldId="256"/>
            <ac:spMk id="2" creationId="{92C564D3-350D-B4F2-0A33-18F6DB91E6A2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09982" y="1178222"/>
            <a:ext cx="9179799" cy="2506427"/>
          </a:xfrm>
        </p:spPr>
        <p:txBody>
          <a:bodyPr anchor="b"/>
          <a:lstStyle>
            <a:lvl1pPr algn="ctr">
              <a:defRPr sz="62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49971" y="3781306"/>
            <a:ext cx="8099822" cy="1738167"/>
          </a:xfrm>
        </p:spPr>
        <p:txBody>
          <a:bodyPr/>
          <a:lstStyle>
            <a:lvl1pPr marL="0" indent="0" algn="ctr">
              <a:buNone/>
              <a:defRPr sz="2520"/>
            </a:lvl1pPr>
            <a:lvl2pPr marL="479969" indent="0" algn="ctr">
              <a:buNone/>
              <a:defRPr sz="2100"/>
            </a:lvl2pPr>
            <a:lvl3pPr marL="959937" indent="0" algn="ctr">
              <a:buNone/>
              <a:defRPr sz="1890"/>
            </a:lvl3pPr>
            <a:lvl4pPr marL="1439906" indent="0" algn="ctr">
              <a:buNone/>
              <a:defRPr sz="1680"/>
            </a:lvl4pPr>
            <a:lvl5pPr marL="1919874" indent="0" algn="ctr">
              <a:buNone/>
              <a:defRPr sz="1680"/>
            </a:lvl5pPr>
            <a:lvl6pPr marL="2399843" indent="0" algn="ctr">
              <a:buNone/>
              <a:defRPr sz="1680"/>
            </a:lvl6pPr>
            <a:lvl7pPr marL="2879811" indent="0" algn="ctr">
              <a:buNone/>
              <a:defRPr sz="1680"/>
            </a:lvl7pPr>
            <a:lvl8pPr marL="3359780" indent="0" algn="ctr">
              <a:buNone/>
              <a:defRPr sz="1680"/>
            </a:lvl8pPr>
            <a:lvl9pPr marL="3839748" indent="0" algn="ctr">
              <a:buNone/>
              <a:defRPr sz="16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41B91-71E8-E740-A0C6-2611C50B0D6F}" type="datetimeFigureOut">
              <a:rPr lang="en-MX" smtClean="0"/>
              <a:t>02/24/2026</a:t>
            </a:fld>
            <a:endParaRPr lang="en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A42BE-6427-424A-8E16-157B482C0B6F}" type="slidenum">
              <a:rPr lang="en-MX" smtClean="0"/>
              <a:t>‹Nº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28542244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41B91-71E8-E740-A0C6-2611C50B0D6F}" type="datetimeFigureOut">
              <a:rPr lang="en-MX" smtClean="0"/>
              <a:t>02/24/2026</a:t>
            </a:fld>
            <a:endParaRPr lang="en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A42BE-6427-424A-8E16-157B482C0B6F}" type="slidenum">
              <a:rPr lang="en-MX" smtClean="0"/>
              <a:t>‹Nº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13321132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728581" y="383297"/>
            <a:ext cx="2328699" cy="610108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42484" y="383297"/>
            <a:ext cx="6851100" cy="610108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41B91-71E8-E740-A0C6-2611C50B0D6F}" type="datetimeFigureOut">
              <a:rPr lang="en-MX" smtClean="0"/>
              <a:t>02/24/2026</a:t>
            </a:fld>
            <a:endParaRPr lang="en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A42BE-6427-424A-8E16-157B482C0B6F}" type="slidenum">
              <a:rPr lang="en-MX" smtClean="0"/>
              <a:t>‹Nº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36633898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41B91-71E8-E740-A0C6-2611C50B0D6F}" type="datetimeFigureOut">
              <a:rPr lang="en-MX" smtClean="0"/>
              <a:t>02/24/2026</a:t>
            </a:fld>
            <a:endParaRPr lang="en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A42BE-6427-424A-8E16-157B482C0B6F}" type="slidenum">
              <a:rPr lang="en-MX" smtClean="0"/>
              <a:t>‹Nº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9738027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6859" y="1794831"/>
            <a:ext cx="9314796" cy="2994714"/>
          </a:xfrm>
        </p:spPr>
        <p:txBody>
          <a:bodyPr anchor="b"/>
          <a:lstStyle>
            <a:lvl1pPr>
              <a:defRPr sz="62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6859" y="4817876"/>
            <a:ext cx="9314796" cy="15748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79969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59937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39906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19874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399843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79811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597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39748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41B91-71E8-E740-A0C6-2611C50B0D6F}" type="datetimeFigureOut">
              <a:rPr lang="en-MX" smtClean="0"/>
              <a:t>02/24/2026</a:t>
            </a:fld>
            <a:endParaRPr lang="en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A42BE-6427-424A-8E16-157B482C0B6F}" type="slidenum">
              <a:rPr lang="en-MX" smtClean="0"/>
              <a:t>‹Nº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40020717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42484" y="1916484"/>
            <a:ext cx="4589899" cy="456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67380" y="1916484"/>
            <a:ext cx="4589899" cy="456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41B91-71E8-E740-A0C6-2611C50B0D6F}" type="datetimeFigureOut">
              <a:rPr lang="en-MX" smtClean="0"/>
              <a:t>02/24/2026</a:t>
            </a:fld>
            <a:endParaRPr lang="en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A42BE-6427-424A-8E16-157B482C0B6F}" type="slidenum">
              <a:rPr lang="en-MX" smtClean="0"/>
              <a:t>‹Nº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32411627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383299"/>
            <a:ext cx="9314796" cy="139153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3892" y="1764832"/>
            <a:ext cx="4568805" cy="864917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79969" indent="0">
              <a:buNone/>
              <a:defRPr sz="2100" b="1"/>
            </a:lvl2pPr>
            <a:lvl3pPr marL="959937" indent="0">
              <a:buNone/>
              <a:defRPr sz="1890" b="1"/>
            </a:lvl3pPr>
            <a:lvl4pPr marL="1439906" indent="0">
              <a:buNone/>
              <a:defRPr sz="1680" b="1"/>
            </a:lvl4pPr>
            <a:lvl5pPr marL="1919874" indent="0">
              <a:buNone/>
              <a:defRPr sz="1680" b="1"/>
            </a:lvl5pPr>
            <a:lvl6pPr marL="2399843" indent="0">
              <a:buNone/>
              <a:defRPr sz="1680" b="1"/>
            </a:lvl6pPr>
            <a:lvl7pPr marL="2879811" indent="0">
              <a:buNone/>
              <a:defRPr sz="1680" b="1"/>
            </a:lvl7pPr>
            <a:lvl8pPr marL="3359780" indent="0">
              <a:buNone/>
              <a:defRPr sz="1680" b="1"/>
            </a:lvl8pPr>
            <a:lvl9pPr marL="3839748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43892" y="2629749"/>
            <a:ext cx="4568805" cy="386796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467381" y="1764832"/>
            <a:ext cx="4591306" cy="864917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79969" indent="0">
              <a:buNone/>
              <a:defRPr sz="2100" b="1"/>
            </a:lvl2pPr>
            <a:lvl3pPr marL="959937" indent="0">
              <a:buNone/>
              <a:defRPr sz="1890" b="1"/>
            </a:lvl3pPr>
            <a:lvl4pPr marL="1439906" indent="0">
              <a:buNone/>
              <a:defRPr sz="1680" b="1"/>
            </a:lvl4pPr>
            <a:lvl5pPr marL="1919874" indent="0">
              <a:buNone/>
              <a:defRPr sz="1680" b="1"/>
            </a:lvl5pPr>
            <a:lvl6pPr marL="2399843" indent="0">
              <a:buNone/>
              <a:defRPr sz="1680" b="1"/>
            </a:lvl6pPr>
            <a:lvl7pPr marL="2879811" indent="0">
              <a:buNone/>
              <a:defRPr sz="1680" b="1"/>
            </a:lvl7pPr>
            <a:lvl8pPr marL="3359780" indent="0">
              <a:buNone/>
              <a:defRPr sz="1680" b="1"/>
            </a:lvl8pPr>
            <a:lvl9pPr marL="3839748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467381" y="2629749"/>
            <a:ext cx="4591306" cy="386796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41B91-71E8-E740-A0C6-2611C50B0D6F}" type="datetimeFigureOut">
              <a:rPr lang="en-MX" smtClean="0"/>
              <a:t>02/24/2026</a:t>
            </a:fld>
            <a:endParaRPr lang="en-MX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A42BE-6427-424A-8E16-157B482C0B6F}" type="slidenum">
              <a:rPr lang="en-MX" smtClean="0"/>
              <a:t>‹Nº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10523763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41B91-71E8-E740-A0C6-2611C50B0D6F}" type="datetimeFigureOut">
              <a:rPr lang="en-MX" smtClean="0"/>
              <a:t>02/24/2026</a:t>
            </a:fld>
            <a:endParaRPr lang="en-MX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A42BE-6427-424A-8E16-157B482C0B6F}" type="slidenum">
              <a:rPr lang="en-MX" smtClean="0"/>
              <a:t>‹Nº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2105989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41B91-71E8-E740-A0C6-2611C50B0D6F}" type="datetimeFigureOut">
              <a:rPr lang="en-MX" smtClean="0"/>
              <a:t>02/24/2026</a:t>
            </a:fld>
            <a:endParaRPr lang="en-MX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A42BE-6427-424A-8E16-157B482C0B6F}" type="slidenum">
              <a:rPr lang="en-MX" smtClean="0"/>
              <a:t>‹Nº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25871580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479954"/>
            <a:ext cx="3483205" cy="1679840"/>
          </a:xfrm>
        </p:spPr>
        <p:txBody>
          <a:bodyPr anchor="b"/>
          <a:lstStyle>
            <a:lvl1pPr>
              <a:defRPr sz="335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91306" y="1036570"/>
            <a:ext cx="5467380" cy="5116178"/>
          </a:xfrm>
        </p:spPr>
        <p:txBody>
          <a:bodyPr/>
          <a:lstStyle>
            <a:lvl1pPr>
              <a:defRPr sz="3359"/>
            </a:lvl1pPr>
            <a:lvl2pPr>
              <a:defRPr sz="2939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2159794"/>
            <a:ext cx="3483205" cy="4001285"/>
          </a:xfrm>
        </p:spPr>
        <p:txBody>
          <a:bodyPr/>
          <a:lstStyle>
            <a:lvl1pPr marL="0" indent="0">
              <a:buNone/>
              <a:defRPr sz="1680"/>
            </a:lvl1pPr>
            <a:lvl2pPr marL="479969" indent="0">
              <a:buNone/>
              <a:defRPr sz="1470"/>
            </a:lvl2pPr>
            <a:lvl3pPr marL="959937" indent="0">
              <a:buNone/>
              <a:defRPr sz="1260"/>
            </a:lvl3pPr>
            <a:lvl4pPr marL="1439906" indent="0">
              <a:buNone/>
              <a:defRPr sz="1050"/>
            </a:lvl4pPr>
            <a:lvl5pPr marL="1919874" indent="0">
              <a:buNone/>
              <a:defRPr sz="1050"/>
            </a:lvl5pPr>
            <a:lvl6pPr marL="2399843" indent="0">
              <a:buNone/>
              <a:defRPr sz="1050"/>
            </a:lvl6pPr>
            <a:lvl7pPr marL="2879811" indent="0">
              <a:buNone/>
              <a:defRPr sz="1050"/>
            </a:lvl7pPr>
            <a:lvl8pPr marL="3359780" indent="0">
              <a:buNone/>
              <a:defRPr sz="1050"/>
            </a:lvl8pPr>
            <a:lvl9pPr marL="3839748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41B91-71E8-E740-A0C6-2611C50B0D6F}" type="datetimeFigureOut">
              <a:rPr lang="en-MX" smtClean="0"/>
              <a:t>02/24/2026</a:t>
            </a:fld>
            <a:endParaRPr lang="en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A42BE-6427-424A-8E16-157B482C0B6F}" type="slidenum">
              <a:rPr lang="en-MX" smtClean="0"/>
              <a:t>‹Nº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10554864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479954"/>
            <a:ext cx="3483205" cy="1679840"/>
          </a:xfrm>
        </p:spPr>
        <p:txBody>
          <a:bodyPr anchor="b"/>
          <a:lstStyle>
            <a:lvl1pPr>
              <a:defRPr sz="335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591306" y="1036570"/>
            <a:ext cx="5467380" cy="5116178"/>
          </a:xfrm>
        </p:spPr>
        <p:txBody>
          <a:bodyPr anchor="t"/>
          <a:lstStyle>
            <a:lvl1pPr marL="0" indent="0">
              <a:buNone/>
              <a:defRPr sz="3359"/>
            </a:lvl1pPr>
            <a:lvl2pPr marL="479969" indent="0">
              <a:buNone/>
              <a:defRPr sz="2939"/>
            </a:lvl2pPr>
            <a:lvl3pPr marL="959937" indent="0">
              <a:buNone/>
              <a:defRPr sz="2520"/>
            </a:lvl3pPr>
            <a:lvl4pPr marL="1439906" indent="0">
              <a:buNone/>
              <a:defRPr sz="2100"/>
            </a:lvl4pPr>
            <a:lvl5pPr marL="1919874" indent="0">
              <a:buNone/>
              <a:defRPr sz="2100"/>
            </a:lvl5pPr>
            <a:lvl6pPr marL="2399843" indent="0">
              <a:buNone/>
              <a:defRPr sz="2100"/>
            </a:lvl6pPr>
            <a:lvl7pPr marL="2879811" indent="0">
              <a:buNone/>
              <a:defRPr sz="2100"/>
            </a:lvl7pPr>
            <a:lvl8pPr marL="3359780" indent="0">
              <a:buNone/>
              <a:defRPr sz="2100"/>
            </a:lvl8pPr>
            <a:lvl9pPr marL="3839748" indent="0">
              <a:buNone/>
              <a:defRPr sz="21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2159794"/>
            <a:ext cx="3483205" cy="4001285"/>
          </a:xfrm>
        </p:spPr>
        <p:txBody>
          <a:bodyPr/>
          <a:lstStyle>
            <a:lvl1pPr marL="0" indent="0">
              <a:buNone/>
              <a:defRPr sz="1680"/>
            </a:lvl1pPr>
            <a:lvl2pPr marL="479969" indent="0">
              <a:buNone/>
              <a:defRPr sz="1470"/>
            </a:lvl2pPr>
            <a:lvl3pPr marL="959937" indent="0">
              <a:buNone/>
              <a:defRPr sz="1260"/>
            </a:lvl3pPr>
            <a:lvl4pPr marL="1439906" indent="0">
              <a:buNone/>
              <a:defRPr sz="1050"/>
            </a:lvl4pPr>
            <a:lvl5pPr marL="1919874" indent="0">
              <a:buNone/>
              <a:defRPr sz="1050"/>
            </a:lvl5pPr>
            <a:lvl6pPr marL="2399843" indent="0">
              <a:buNone/>
              <a:defRPr sz="1050"/>
            </a:lvl6pPr>
            <a:lvl7pPr marL="2879811" indent="0">
              <a:buNone/>
              <a:defRPr sz="1050"/>
            </a:lvl7pPr>
            <a:lvl8pPr marL="3359780" indent="0">
              <a:buNone/>
              <a:defRPr sz="1050"/>
            </a:lvl8pPr>
            <a:lvl9pPr marL="3839748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41B91-71E8-E740-A0C6-2611C50B0D6F}" type="datetimeFigureOut">
              <a:rPr lang="en-MX" smtClean="0"/>
              <a:t>02/24/2026</a:t>
            </a:fld>
            <a:endParaRPr lang="en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A42BE-6427-424A-8E16-157B482C0B6F}" type="slidenum">
              <a:rPr lang="en-MX" smtClean="0"/>
              <a:t>‹Nº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15245069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42484" y="383299"/>
            <a:ext cx="9314796" cy="1391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2484" y="1916484"/>
            <a:ext cx="9314796" cy="45678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42484" y="6672698"/>
            <a:ext cx="2429947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441B91-71E8-E740-A0C6-2611C50B0D6F}" type="datetimeFigureOut">
              <a:rPr lang="en-MX" smtClean="0"/>
              <a:t>02/24/2026</a:t>
            </a:fld>
            <a:endParaRPr lang="en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77422" y="6672698"/>
            <a:ext cx="3644920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627332" y="6672698"/>
            <a:ext cx="2429947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EA42BE-6427-424A-8E16-157B482C0B6F}" type="slidenum">
              <a:rPr lang="en-MX" smtClean="0"/>
              <a:t>‹Nº›</a:t>
            </a:fld>
            <a:endParaRPr lang="en-MX"/>
          </a:p>
        </p:txBody>
      </p:sp>
    </p:spTree>
    <p:extLst>
      <p:ext uri="{BB962C8B-B14F-4D97-AF65-F5344CB8AC3E}">
        <p14:creationId xmlns:p14="http://schemas.microsoft.com/office/powerpoint/2010/main" val="4372116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59937" rtl="0" eaLnBrk="1" latinLnBrk="0" hangingPunct="1">
        <a:lnSpc>
          <a:spcPct val="90000"/>
        </a:lnSpc>
        <a:spcBef>
          <a:spcPct val="0"/>
        </a:spcBef>
        <a:buNone/>
        <a:defRPr sz="461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39984" indent="-239984" algn="l" defTabSz="959937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39" kern="1200">
          <a:solidFill>
            <a:schemeClr val="tx1"/>
          </a:solidFill>
          <a:latin typeface="+mn-lt"/>
          <a:ea typeface="+mn-ea"/>
          <a:cs typeface="+mn-cs"/>
        </a:defRPr>
      </a:lvl1pPr>
      <a:lvl2pPr marL="719953" indent="-239984" algn="l" defTabSz="959937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199921" indent="-239984" algn="l" defTabSz="959937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79890" indent="-239984" algn="l" defTabSz="959937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59859" indent="-239984" algn="l" defTabSz="959937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39827" indent="-239984" algn="l" defTabSz="959937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19796" indent="-239984" algn="l" defTabSz="959937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599764" indent="-239984" algn="l" defTabSz="959937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79733" indent="-239984" algn="l" defTabSz="959937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59937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79969" algn="l" defTabSz="959937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59937" algn="l" defTabSz="959937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39906" algn="l" defTabSz="959937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19874" algn="l" defTabSz="959937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399843" algn="l" defTabSz="959937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79811" algn="l" defTabSz="959937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59780" algn="l" defTabSz="959937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39748" algn="l" defTabSz="959937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EC1095C-E6C7-6944-9CCD-2C779B25A123}"/>
              </a:ext>
            </a:extLst>
          </p:cNvPr>
          <p:cNvSpPr txBox="1"/>
          <p:nvPr/>
        </p:nvSpPr>
        <p:spPr>
          <a:xfrm>
            <a:off x="5689632" y="-73777"/>
            <a:ext cx="184731" cy="5012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MX" sz="2657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CA71C516-64F1-7242-9A5E-D1E793B454BF}"/>
              </a:ext>
            </a:extLst>
          </p:cNvPr>
          <p:cNvSpPr/>
          <p:nvPr/>
        </p:nvSpPr>
        <p:spPr>
          <a:xfrm>
            <a:off x="4658138" y="5713651"/>
            <a:ext cx="1769191" cy="2846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ime (day number)</a:t>
            </a:r>
            <a:r>
              <a:rPr lang="en-US" sz="12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endParaRPr lang="en-MX" sz="12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0AC52ECB-2839-2B46-A40B-DD7FA67EE37A}"/>
              </a:ext>
            </a:extLst>
          </p:cNvPr>
          <p:cNvSpPr/>
          <p:nvPr/>
        </p:nvSpPr>
        <p:spPr>
          <a:xfrm rot="16200000">
            <a:off x="1085455" y="3217464"/>
            <a:ext cx="2160000" cy="2846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ffective number of species</a:t>
            </a:r>
            <a:r>
              <a:rPr lang="en-US" sz="12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endParaRPr lang="en-MX" sz="12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34FDC11B-2EE0-344E-8A92-4F66FA8C3D1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52022" y="3359811"/>
            <a:ext cx="2497995" cy="21600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7668C53B-76C8-5E4C-B322-78971EC40B8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2022" y="1257442"/>
            <a:ext cx="2497995" cy="2160000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7471A877-C7A3-A945-8009-56C6A2D7FECA}"/>
              </a:ext>
            </a:extLst>
          </p:cNvPr>
          <p:cNvSpPr/>
          <p:nvPr/>
        </p:nvSpPr>
        <p:spPr>
          <a:xfrm>
            <a:off x="2916728" y="887803"/>
            <a:ext cx="1888308" cy="2846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" sz="12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) Bacteria</a:t>
            </a:r>
            <a:endParaRPr lang="en-MX" sz="12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8A2F0BFE-E74E-A048-AD88-4989816AE2C5}"/>
              </a:ext>
            </a:extLst>
          </p:cNvPr>
          <p:cNvSpPr/>
          <p:nvPr/>
        </p:nvSpPr>
        <p:spPr>
          <a:xfrm>
            <a:off x="5856441" y="838593"/>
            <a:ext cx="1888308" cy="2846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" sz="125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) Archaea</a:t>
            </a:r>
            <a:endParaRPr lang="en-MX" sz="12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47948FCC-A275-0C42-98E2-CD8C7E5EF1A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387053" y="3359811"/>
            <a:ext cx="2497995" cy="216000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398927A1-8198-C443-8C76-D76BA6CC24F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387053" y="1199810"/>
            <a:ext cx="2497995" cy="2160000"/>
          </a:xfrm>
          <a:prstGeom prst="rect">
            <a:avLst/>
          </a:prstGeom>
        </p:spPr>
      </p:pic>
      <p:sp>
        <p:nvSpPr>
          <p:cNvPr id="20" name="Rectangle 19">
            <a:extLst>
              <a:ext uri="{FF2B5EF4-FFF2-40B4-BE49-F238E27FC236}">
                <a16:creationId xmlns:a16="http://schemas.microsoft.com/office/drawing/2014/main" id="{FB2CF546-6D34-C24F-ACC5-6FF2F6533CB1}"/>
              </a:ext>
            </a:extLst>
          </p:cNvPr>
          <p:cNvSpPr/>
          <p:nvPr/>
        </p:nvSpPr>
        <p:spPr>
          <a:xfrm>
            <a:off x="2932196" y="1447697"/>
            <a:ext cx="1888308" cy="2846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" sz="1250" i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q</a:t>
            </a:r>
            <a:r>
              <a:rPr lang="es-ES" sz="12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0: 4222±180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7EE3EB4D-D7CE-CA4A-8E60-CD9EBDED8ADD}"/>
              </a:ext>
            </a:extLst>
          </p:cNvPr>
          <p:cNvSpPr/>
          <p:nvPr/>
        </p:nvSpPr>
        <p:spPr>
          <a:xfrm>
            <a:off x="2922612" y="3237517"/>
            <a:ext cx="1888308" cy="2846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" sz="1250" i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q</a:t>
            </a:r>
            <a:r>
              <a:rPr lang="es-ES" sz="12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1: 385±101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7ADE0441-ACF6-554F-86FD-926A7033A167}"/>
              </a:ext>
            </a:extLst>
          </p:cNvPr>
          <p:cNvSpPr/>
          <p:nvPr/>
        </p:nvSpPr>
        <p:spPr>
          <a:xfrm>
            <a:off x="2886490" y="4697540"/>
            <a:ext cx="1888308" cy="2846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" sz="1250" i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q</a:t>
            </a:r>
            <a:r>
              <a:rPr lang="es-ES" sz="12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2: 50±18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ECD0E9F9-D867-984D-9914-78681AC04979}"/>
              </a:ext>
            </a:extLst>
          </p:cNvPr>
          <p:cNvSpPr/>
          <p:nvPr/>
        </p:nvSpPr>
        <p:spPr>
          <a:xfrm>
            <a:off x="5875819" y="1456637"/>
            <a:ext cx="1888308" cy="2846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" sz="1250" i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q</a:t>
            </a:r>
            <a:r>
              <a:rPr lang="es-ES" sz="12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0: 237±8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FEAAA75B-25F9-7845-B198-AA3B8E6B78AF}"/>
              </a:ext>
            </a:extLst>
          </p:cNvPr>
          <p:cNvSpPr/>
          <p:nvPr/>
        </p:nvSpPr>
        <p:spPr>
          <a:xfrm>
            <a:off x="5875819" y="3172037"/>
            <a:ext cx="1888308" cy="2846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" sz="1250" i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q</a:t>
            </a:r>
            <a:r>
              <a:rPr lang="es-ES" sz="12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1: 7.61±1.01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CC7F8C57-8856-E24D-876C-C446F2E6B4B1}"/>
              </a:ext>
            </a:extLst>
          </p:cNvPr>
          <p:cNvSpPr/>
          <p:nvPr/>
        </p:nvSpPr>
        <p:spPr>
          <a:xfrm>
            <a:off x="5875819" y="4252037"/>
            <a:ext cx="1888308" cy="2846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" sz="1250" i="1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q</a:t>
            </a:r>
            <a:r>
              <a:rPr lang="es-ES" sz="125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2: </a:t>
            </a:r>
            <a:r>
              <a:rPr lang="es-ES" sz="125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3.26±0.46</a:t>
            </a:r>
          </a:p>
        </p:txBody>
      </p:sp>
      <p:sp>
        <p:nvSpPr>
          <p:cNvPr id="2" name="CuadroTexto 2">
            <a:extLst>
              <a:ext uri="{FF2B5EF4-FFF2-40B4-BE49-F238E27FC236}">
                <a16:creationId xmlns:a16="http://schemas.microsoft.com/office/drawing/2014/main" id="{92C564D3-350D-B4F2-0A33-18F6DB91E6A2}"/>
              </a:ext>
            </a:extLst>
          </p:cNvPr>
          <p:cNvSpPr txBox="1"/>
          <p:nvPr/>
        </p:nvSpPr>
        <p:spPr>
          <a:xfrm>
            <a:off x="241863" y="6274355"/>
            <a:ext cx="1060173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MX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b="1" dirty="0"/>
              <a:t>A nitrification bioreactor applied solely with ammonium and inorganic C maintains a highly diverse bacterial and archaeal community even after nine years</a:t>
            </a:r>
            <a:endParaRPr lang="es-MX" dirty="0"/>
          </a:p>
          <a:p>
            <a:endParaRPr lang="es-MX" dirty="0"/>
          </a:p>
        </p:txBody>
      </p:sp>
    </p:spTree>
    <p:extLst>
      <p:ext uri="{BB962C8B-B14F-4D97-AF65-F5344CB8AC3E}">
        <p14:creationId xmlns:p14="http://schemas.microsoft.com/office/powerpoint/2010/main" val="25278682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09</TotalTime>
  <Words>67</Words>
  <Application>Microsoft Office PowerPoint</Application>
  <PresentationFormat>Personalizado</PresentationFormat>
  <Paragraphs>1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endi Navarro</dc:creator>
  <cp:lastModifiedBy>Saul Lopez Vazquez</cp:lastModifiedBy>
  <cp:revision>15</cp:revision>
  <cp:lastPrinted>2021-03-02T01:44:37Z</cp:lastPrinted>
  <dcterms:created xsi:type="dcterms:W3CDTF">2021-02-25T23:01:40Z</dcterms:created>
  <dcterms:modified xsi:type="dcterms:W3CDTF">2026-02-24T17:24:50Z</dcterms:modified>
</cp:coreProperties>
</file>